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11449-FD9D-425A-817B-47BFAF9CBC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1B185-F676-4A9A-AD98-405B9B57C0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C3966-A928-4441-910F-72E64E980A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99590-6028-43E1-8376-3281CE5E97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DDB96-BD96-4A39-A064-86E20ECF0A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0DEA6-DB94-463C-AC55-1DB59293E4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5E183-D6D6-4D4B-8907-86253F378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EF370-B1FD-4AF8-9F2E-0FDEAF6A2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FDBF1-7499-436C-8737-400302D16E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01A5B-1430-4DA1-BE38-3BFA787296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04D38-AA54-4A81-9F46-7C82BF1901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88242-5E25-4554-B25F-873F81BC0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8BE264-BC0E-42F4-BFA8-28C915D400A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0"/>
          <p:cNvSpPr/>
          <p:nvPr/>
        </p:nvSpPr>
        <p:spPr>
          <a:xfrm>
            <a:off x="762120" y="1500120"/>
            <a:ext cx="1082520" cy="307080"/>
          </a:xfrm>
          <a:prstGeom prst="rect">
            <a:avLst/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Tumour-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4"/>
          <p:cNvGrpSpPr/>
          <p:nvPr/>
        </p:nvGrpSpPr>
        <p:grpSpPr>
          <a:xfrm>
            <a:off x="1911240" y="458640"/>
            <a:ext cx="3303720" cy="2523240"/>
            <a:chOff x="1911240" y="458640"/>
            <a:chExt cx="3303720" cy="2523240"/>
          </a:xfrm>
        </p:grpSpPr>
        <p:pic>
          <p:nvPicPr>
            <p:cNvPr id="43" name="Picture 6" descr=""/>
            <p:cNvPicPr/>
            <p:nvPr/>
          </p:nvPicPr>
          <p:blipFill>
            <a:blip r:embed="rId1"/>
            <a:stretch/>
          </p:blipFill>
          <p:spPr>
            <a:xfrm>
              <a:off x="1911240" y="458640"/>
              <a:ext cx="3303720" cy="2521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4" name="Text Box 11"/>
            <p:cNvSpPr/>
            <p:nvPr/>
          </p:nvSpPr>
          <p:spPr>
            <a:xfrm>
              <a:off x="4260960" y="142704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S100A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 Box 13"/>
            <p:cNvSpPr/>
            <p:nvPr/>
          </p:nvSpPr>
          <p:spPr>
            <a:xfrm>
              <a:off x="2531880" y="2674800"/>
              <a:ext cx="1093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Annexin-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 Box 14"/>
            <p:cNvSpPr/>
            <p:nvPr/>
          </p:nvSpPr>
          <p:spPr>
            <a:xfrm>
              <a:off x="4260960" y="26748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DA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 Box 16"/>
            <p:cNvSpPr/>
            <p:nvPr/>
          </p:nvSpPr>
          <p:spPr>
            <a:xfrm>
              <a:off x="2840040" y="142704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8" name="Group 23"/>
          <p:cNvGrpSpPr/>
          <p:nvPr/>
        </p:nvGrpSpPr>
        <p:grpSpPr>
          <a:xfrm>
            <a:off x="1911240" y="3071880"/>
            <a:ext cx="3305160" cy="2520720"/>
            <a:chOff x="1911240" y="3071880"/>
            <a:chExt cx="3305160" cy="2520720"/>
          </a:xfrm>
        </p:grpSpPr>
        <p:pic>
          <p:nvPicPr>
            <p:cNvPr id="49" name="Picture 4" descr=""/>
            <p:cNvPicPr/>
            <p:nvPr/>
          </p:nvPicPr>
          <p:blipFill>
            <a:blip r:embed="rId2"/>
            <a:stretch/>
          </p:blipFill>
          <p:spPr>
            <a:xfrm>
              <a:off x="1911240" y="3071880"/>
              <a:ext cx="3305160" cy="2520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0" name="Text Box 11"/>
            <p:cNvSpPr/>
            <p:nvPr/>
          </p:nvSpPr>
          <p:spPr>
            <a:xfrm>
              <a:off x="4279680" y="402732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S100A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 Box 13"/>
            <p:cNvSpPr/>
            <p:nvPr/>
          </p:nvSpPr>
          <p:spPr>
            <a:xfrm>
              <a:off x="2550960" y="5284800"/>
              <a:ext cx="1093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Annexin-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4279680" y="52848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DA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 Box 16"/>
            <p:cNvSpPr/>
            <p:nvPr/>
          </p:nvSpPr>
          <p:spPr>
            <a:xfrm>
              <a:off x="2858760" y="402732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4" name="Group 22"/>
          <p:cNvGrpSpPr/>
          <p:nvPr/>
        </p:nvGrpSpPr>
        <p:grpSpPr>
          <a:xfrm>
            <a:off x="1911240" y="5694480"/>
            <a:ext cx="3303720" cy="2520720"/>
            <a:chOff x="1911240" y="5694480"/>
            <a:chExt cx="3303720" cy="2520720"/>
          </a:xfrm>
        </p:grpSpPr>
        <p:pic>
          <p:nvPicPr>
            <p:cNvPr id="55" name="Picture 23" descr=""/>
            <p:cNvPicPr/>
            <p:nvPr/>
          </p:nvPicPr>
          <p:blipFill>
            <a:blip r:embed="rId3"/>
            <a:stretch/>
          </p:blipFill>
          <p:spPr>
            <a:xfrm>
              <a:off x="1911240" y="5694480"/>
              <a:ext cx="3303720" cy="2520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6" name="Text Box 11"/>
            <p:cNvSpPr/>
            <p:nvPr/>
          </p:nvSpPr>
          <p:spPr>
            <a:xfrm>
              <a:off x="4260960" y="664668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S100A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 Box 13"/>
            <p:cNvSpPr/>
            <p:nvPr/>
          </p:nvSpPr>
          <p:spPr>
            <a:xfrm>
              <a:off x="2531880" y="7904160"/>
              <a:ext cx="1093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Annexin-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 Box 14"/>
            <p:cNvSpPr/>
            <p:nvPr/>
          </p:nvSpPr>
          <p:spPr>
            <a:xfrm>
              <a:off x="4260960" y="790416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DAP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 Box 16"/>
            <p:cNvSpPr/>
            <p:nvPr/>
          </p:nvSpPr>
          <p:spPr>
            <a:xfrm>
              <a:off x="2840040" y="664668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Calibri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Text Box 20"/>
          <p:cNvSpPr/>
          <p:nvPr/>
        </p:nvSpPr>
        <p:spPr>
          <a:xfrm>
            <a:off x="762120" y="4186080"/>
            <a:ext cx="1082520" cy="307080"/>
          </a:xfrm>
          <a:prstGeom prst="rect">
            <a:avLst/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Tumour-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20"/>
          <p:cNvSpPr/>
          <p:nvPr/>
        </p:nvSpPr>
        <p:spPr>
          <a:xfrm>
            <a:off x="762120" y="6757920"/>
            <a:ext cx="1082520" cy="307080"/>
          </a:xfrm>
          <a:prstGeom prst="rect">
            <a:avLst/>
          </a:prstGeom>
          <a:solidFill>
            <a:srgbClr val="f2f2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Tumour-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3"/>
          <p:cNvSpPr/>
          <p:nvPr/>
        </p:nvSpPr>
        <p:spPr>
          <a:xfrm>
            <a:off x="428760" y="8478720"/>
            <a:ext cx="442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Nedjadi et al., Supplementary Information, Figure 1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3T14:23:01Z</dcterms:created>
  <dc:creator>sidibbk</dc:creator>
  <dc:description/>
  <dc:language>en-US</dc:language>
  <cp:lastModifiedBy>sidibbk</cp:lastModifiedBy>
  <dcterms:modified xsi:type="dcterms:W3CDTF">2009-07-23T14:41:14Z</dcterms:modified>
  <cp:revision>1</cp:revision>
  <dc:subject/>
  <dc:title>Slide 1</dc:title>
</cp:coreProperties>
</file>